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C0654-5AC5-4AE7-BAE9-0817E7E6FBC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55FB-4E26-43D2-9B9B-469DEA84C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686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C0654-5AC5-4AE7-BAE9-0817E7E6FBC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55FB-4E26-43D2-9B9B-469DEA84C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264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C0654-5AC5-4AE7-BAE9-0817E7E6FBC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55FB-4E26-43D2-9B9B-469DEA84C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035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C0654-5AC5-4AE7-BAE9-0817E7E6FBC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55FB-4E26-43D2-9B9B-469DEA84C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560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C0654-5AC5-4AE7-BAE9-0817E7E6FBC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55FB-4E26-43D2-9B9B-469DEA84C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303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C0654-5AC5-4AE7-BAE9-0817E7E6FBC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55FB-4E26-43D2-9B9B-469DEA84C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129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C0654-5AC5-4AE7-BAE9-0817E7E6FBC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55FB-4E26-43D2-9B9B-469DEA84C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1059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C0654-5AC5-4AE7-BAE9-0817E7E6FBC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55FB-4E26-43D2-9B9B-469DEA84C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167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C0654-5AC5-4AE7-BAE9-0817E7E6FBC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55FB-4E26-43D2-9B9B-469DEA84C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3776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C0654-5AC5-4AE7-BAE9-0817E7E6FBC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55FB-4E26-43D2-9B9B-469DEA84C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405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C0654-5AC5-4AE7-BAE9-0817E7E6FBC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155FB-4E26-43D2-9B9B-469DEA84C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3550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FC0654-5AC5-4AE7-BAE9-0817E7E6FBC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7155FB-4E26-43D2-9B9B-469DEA84CA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713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C:\Users\Lab1\Desktop\01.tif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23944" y="332656"/>
            <a:ext cx="5760000" cy="1440000"/>
          </a:xfrm>
          <a:prstGeom prst="rect">
            <a:avLst/>
          </a:prstGeom>
          <a:noFill/>
        </p:spPr>
      </p:pic>
      <p:pic>
        <p:nvPicPr>
          <p:cNvPr id="6" name="Picture 2" descr="C:\Users\Lab1\Desktop\01.tif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423944" y="1799952"/>
            <a:ext cx="5760000" cy="1440000"/>
          </a:xfrm>
          <a:prstGeom prst="rect">
            <a:avLst/>
          </a:prstGeom>
          <a:noFill/>
        </p:spPr>
      </p:pic>
      <p:pic>
        <p:nvPicPr>
          <p:cNvPr id="7" name="Picture 4" descr="C:\Users\Lab1\Desktop\03.tif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423944" y="3275952"/>
            <a:ext cx="5760000" cy="1440000"/>
          </a:xfrm>
          <a:prstGeom prst="rect">
            <a:avLst/>
          </a:prstGeom>
          <a:noFill/>
        </p:spPr>
      </p:pic>
      <p:sp>
        <p:nvSpPr>
          <p:cNvPr id="8" name="CasellaDiTesto 7"/>
          <p:cNvSpPr txBox="1"/>
          <p:nvPr/>
        </p:nvSpPr>
        <p:spPr>
          <a:xfrm>
            <a:off x="1991544" y="920059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P2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Connettore 1 8"/>
          <p:cNvCxnSpPr/>
          <p:nvPr/>
        </p:nvCxnSpPr>
        <p:spPr>
          <a:xfrm>
            <a:off x="1991544" y="548944"/>
            <a:ext cx="0" cy="237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sellaDiTesto 9"/>
          <p:cNvSpPr txBox="1"/>
          <p:nvPr/>
        </p:nvSpPr>
        <p:spPr>
          <a:xfrm>
            <a:off x="1991544" y="2360219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P15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1984048" y="3944395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P2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Connettore 1 12"/>
          <p:cNvCxnSpPr/>
          <p:nvPr/>
        </p:nvCxnSpPr>
        <p:spPr>
          <a:xfrm>
            <a:off x="1984048" y="3573280"/>
            <a:ext cx="0" cy="237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asellaDiTesto 13"/>
          <p:cNvSpPr txBox="1"/>
          <p:nvPr/>
        </p:nvSpPr>
        <p:spPr>
          <a:xfrm>
            <a:off x="1984048" y="5384555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P15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3" name="Gruppo 32"/>
          <p:cNvGrpSpPr/>
          <p:nvPr/>
        </p:nvGrpSpPr>
        <p:grpSpPr>
          <a:xfrm>
            <a:off x="2423944" y="4734496"/>
            <a:ext cx="5760288" cy="1440000"/>
            <a:chOff x="899944" y="4734496"/>
            <a:chExt cx="5760288" cy="1440000"/>
          </a:xfrm>
        </p:grpSpPr>
        <p:pic>
          <p:nvPicPr>
            <p:cNvPr id="4" name="Picture 3" descr="C:\Users\Lab1\Desktop\00.tif"/>
            <p:cNvPicPr preferRelativeResize="0">
              <a:picLocks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899944" y="4734496"/>
              <a:ext cx="5760000" cy="1440000"/>
            </a:xfrm>
            <a:prstGeom prst="rect">
              <a:avLst/>
            </a:prstGeom>
            <a:noFill/>
          </p:spPr>
        </p:pic>
        <p:sp>
          <p:nvSpPr>
            <p:cNvPr id="16" name="CasellaDiTesto 15"/>
            <p:cNvSpPr txBox="1"/>
            <p:nvPr/>
          </p:nvSpPr>
          <p:spPr>
            <a:xfrm>
              <a:off x="6334502" y="591908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__</a:t>
              </a:r>
              <a:endParaRPr lang="it-IT" sz="10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7" name="CasellaDiTesto 16"/>
          <p:cNvSpPr txBox="1"/>
          <p:nvPr/>
        </p:nvSpPr>
        <p:spPr>
          <a:xfrm>
            <a:off x="2423592" y="33265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A1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>
            <a:off x="3863752" y="33265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A2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>
            <a:off x="5303912" y="33265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A3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>
            <a:off x="6744072" y="33265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A4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2423592" y="177281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B1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CasellaDiTesto 21"/>
          <p:cNvSpPr txBox="1"/>
          <p:nvPr/>
        </p:nvSpPr>
        <p:spPr>
          <a:xfrm>
            <a:off x="3863752" y="177281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B2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CasellaDiTesto 22"/>
          <p:cNvSpPr txBox="1"/>
          <p:nvPr/>
        </p:nvSpPr>
        <p:spPr>
          <a:xfrm>
            <a:off x="5303912" y="177281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B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3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CasellaDiTesto 23"/>
          <p:cNvSpPr txBox="1"/>
          <p:nvPr/>
        </p:nvSpPr>
        <p:spPr>
          <a:xfrm>
            <a:off x="6744072" y="177281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B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4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CasellaDiTesto 24"/>
          <p:cNvSpPr txBox="1"/>
          <p:nvPr/>
        </p:nvSpPr>
        <p:spPr>
          <a:xfrm>
            <a:off x="2423592" y="3275952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C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1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3863752" y="3275952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C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2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5303912" y="3275952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C3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CasellaDiTesto 27"/>
          <p:cNvSpPr txBox="1"/>
          <p:nvPr/>
        </p:nvSpPr>
        <p:spPr>
          <a:xfrm>
            <a:off x="6744072" y="3275952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C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4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CasellaDiTesto 28"/>
          <p:cNvSpPr txBox="1"/>
          <p:nvPr/>
        </p:nvSpPr>
        <p:spPr>
          <a:xfrm>
            <a:off x="2423592" y="4734496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D1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CasellaDiTesto 29"/>
          <p:cNvSpPr txBox="1"/>
          <p:nvPr/>
        </p:nvSpPr>
        <p:spPr>
          <a:xfrm>
            <a:off x="3863752" y="4734496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D2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CasellaDiTesto 30"/>
          <p:cNvSpPr txBox="1"/>
          <p:nvPr/>
        </p:nvSpPr>
        <p:spPr>
          <a:xfrm>
            <a:off x="5303912" y="4734496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D3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CasellaDiTesto 31"/>
          <p:cNvSpPr txBox="1"/>
          <p:nvPr/>
        </p:nvSpPr>
        <p:spPr>
          <a:xfrm>
            <a:off x="6744072" y="4734496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D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4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CasellaDiTesto 34"/>
          <p:cNvSpPr txBox="1"/>
          <p:nvPr/>
        </p:nvSpPr>
        <p:spPr>
          <a:xfrm>
            <a:off x="1557865" y="1691922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i="1" dirty="0">
                <a:latin typeface="Arial" pitchFamily="34" charset="0"/>
                <a:cs typeface="Arial" pitchFamily="34" charset="0"/>
              </a:rPr>
              <a:t>p16</a:t>
            </a:r>
            <a:endParaRPr lang="it-IT" sz="1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CasellaDiTesto 35"/>
          <p:cNvSpPr txBox="1"/>
          <p:nvPr/>
        </p:nvSpPr>
        <p:spPr>
          <a:xfrm>
            <a:off x="1550368" y="471625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i="1" dirty="0">
                <a:latin typeface="Arial" pitchFamily="34" charset="0"/>
                <a:cs typeface="Arial" pitchFamily="34" charset="0"/>
              </a:rPr>
              <a:t>p21</a:t>
            </a:r>
            <a:endParaRPr lang="it-IT" sz="1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CasellaDiTesto 36"/>
          <p:cNvSpPr txBox="1"/>
          <p:nvPr/>
        </p:nvSpPr>
        <p:spPr>
          <a:xfrm>
            <a:off x="8184232" y="332657"/>
            <a:ext cx="2304256" cy="4893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S2.  </a:t>
            </a:r>
            <a:endParaRPr lang="it-IT" sz="1200" dirty="0">
              <a:latin typeface="Arial" pitchFamily="34" charset="0"/>
              <a:cs typeface="Arial" pitchFamily="34" charset="0"/>
            </a:endParaRPr>
          </a:p>
          <a:p>
            <a:pPr algn="just"/>
            <a:r>
              <a:rPr lang="en-US" sz="1200" dirty="0">
                <a:latin typeface="Arial" pitchFamily="34" charset="0"/>
                <a:cs typeface="Arial" pitchFamily="34" charset="0"/>
              </a:rPr>
              <a:t>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2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C2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hDPSC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at P2 show low expression of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16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nd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21 (red fluorescent)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s indicated by double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immunostaining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3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C3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Cells at P2 labeled with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phalloid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488 (green fluorescent) to evidence the cytoskeleton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act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C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Cell nuclei at P2 stained with TOPRO (blue fluorescent)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4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C4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Merge micrographs of above three channels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2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D2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hDPSC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at P15 show low expression of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16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nd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21 (red fluorescent)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as indicated by double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immunostaining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3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D3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Cells at P2 labeled with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phalloid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488 (green fluorescent) to evidence the cytoskeleton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act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D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Cell nuclei at P2 stained with TOPRO (blue fluorescent)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4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D4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Merge micrographs of above three channels.</a:t>
            </a:r>
            <a:endParaRPr lang="it-IT" sz="1200" dirty="0">
              <a:latin typeface="Arial" pitchFamily="34" charset="0"/>
              <a:cs typeface="Arial" pitchFamily="34" charset="0"/>
            </a:endParaRPr>
          </a:p>
          <a:p>
            <a:pPr algn="just"/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16415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6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ro, Dina</dc:creator>
  <cp:lastModifiedBy>Jaro, Dina</cp:lastModifiedBy>
  <cp:revision>1</cp:revision>
  <dcterms:created xsi:type="dcterms:W3CDTF">2017-03-22T22:40:15Z</dcterms:created>
  <dcterms:modified xsi:type="dcterms:W3CDTF">2017-03-22T22:40:23Z</dcterms:modified>
</cp:coreProperties>
</file>